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30607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-72" y="-508"/>
      </p:cViewPr>
      <p:guideLst>
        <p:guide orient="horz" pos="964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841616093559538"/>
          <c:y val="0.11353257874213354"/>
          <c:w val="0.84158372756058852"/>
          <c:h val="0.7874472280857682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wild typ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Sheet2!$C$2:$C$5</c:f>
                <c:numCache>
                  <c:formatCode>General</c:formatCode>
                  <c:ptCount val="4"/>
                  <c:pt idx="0">
                    <c:v>6.1215565E-2</c:v>
                  </c:pt>
                  <c:pt idx="1">
                    <c:v>3.2726440000000002E-2</c:v>
                  </c:pt>
                  <c:pt idx="2">
                    <c:v>4.4055434999999997E-2</c:v>
                  </c:pt>
                  <c:pt idx="3">
                    <c:v>6.3770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/>
            </c:spPr>
          </c:errBars>
          <c:cat>
            <c:strRef>
              <c:f>Sheet1!$A$2:$A$5</c:f>
              <c:strCache>
                <c:ptCount val="4"/>
                <c:pt idx="0">
                  <c:v>Control</c:v>
                </c:pt>
                <c:pt idx="1">
                  <c:v>SRT1720</c:v>
                </c:pt>
                <c:pt idx="2">
                  <c:v>LPS</c:v>
                </c:pt>
                <c:pt idx="3">
                  <c:v>SRT1720+lps</c:v>
                </c:pt>
              </c:strCache>
            </c:strRef>
          </c:cat>
          <c:val>
            <c:numRef>
              <c:f>Sheet1!$B$2:$B$5</c:f>
              <c:numCache>
                <c:formatCode>General</c:formatCode>
                <c:ptCount val="4"/>
                <c:pt idx="0">
                  <c:v>1</c:v>
                </c:pt>
                <c:pt idx="1">
                  <c:v>0.78677430000000004</c:v>
                </c:pt>
                <c:pt idx="2">
                  <c:v>0.94062970000000001</c:v>
                </c:pt>
                <c:pt idx="3">
                  <c:v>0.8862902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6"/>
        <c:axId val="422316672"/>
        <c:axId val="422318464"/>
      </c:barChart>
      <c:catAx>
        <c:axId val="4223166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txPr>
          <a:bodyPr/>
          <a:lstStyle/>
          <a:p>
            <a:pPr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zh-CN"/>
          </a:p>
        </c:txPr>
        <c:crossAx val="422318464"/>
        <c:crosses val="autoZero"/>
        <c:auto val="1"/>
        <c:lblAlgn val="ctr"/>
        <c:lblOffset val="100"/>
        <c:noMultiLvlLbl val="0"/>
      </c:catAx>
      <c:valAx>
        <c:axId val="4223184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zh-CN"/>
          </a:p>
        </c:txPr>
        <c:crossAx val="42231667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zh-CN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5594</cdr:x>
      <cdr:y>0.88235</cdr:y>
    </cdr:from>
    <cdr:to>
      <cdr:x>0.93566</cdr:x>
      <cdr:y>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576064" y="2362191"/>
          <a:ext cx="2880320" cy="2880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zh-CN" altLang="en-US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950801"/>
            <a:ext cx="7772400" cy="656067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1734397"/>
            <a:ext cx="6400800" cy="78217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122570"/>
            <a:ext cx="2057400" cy="2611514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122570"/>
            <a:ext cx="6019800" cy="2611514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1966783"/>
            <a:ext cx="7772400" cy="607889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1297255"/>
            <a:ext cx="7772400" cy="66952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714163"/>
            <a:ext cx="4038600" cy="201992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714163"/>
            <a:ext cx="4038600" cy="201992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685115"/>
            <a:ext cx="4040188" cy="28552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970639"/>
            <a:ext cx="4040188" cy="176344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6" y="685115"/>
            <a:ext cx="4041775" cy="28552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6" y="970639"/>
            <a:ext cx="4041775" cy="176344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1" y="121861"/>
            <a:ext cx="3008313" cy="51861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121861"/>
            <a:ext cx="5111750" cy="261222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1" y="640480"/>
            <a:ext cx="3008313" cy="209360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2142490"/>
            <a:ext cx="5486400" cy="25293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273479"/>
            <a:ext cx="5486400" cy="183642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2395423"/>
            <a:ext cx="5486400" cy="35920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122570"/>
            <a:ext cx="8229600" cy="5101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714163"/>
            <a:ext cx="8229600" cy="201992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2836816"/>
            <a:ext cx="2133600" cy="16295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10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2836816"/>
            <a:ext cx="2895600" cy="16295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2836816"/>
            <a:ext cx="2133600" cy="16295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 descr="D:\文件\sepsis sirt1 permeability\结果\wb结果分析\srt1720 p53\2\a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08" t="40242" r="39990" b="50161"/>
          <a:stretch/>
        </p:blipFill>
        <p:spPr bwMode="auto">
          <a:xfrm>
            <a:off x="1898081" y="1659898"/>
            <a:ext cx="2373614" cy="250442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D:\文件\sepsis sirt1 permeability\结果\wb结果分析\srt1720 p53\2\p53.tif"/>
          <p:cNvPicPr>
            <a:picLocks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94" t="43235" r="34653" b="46326"/>
          <a:stretch/>
        </p:blipFill>
        <p:spPr bwMode="auto">
          <a:xfrm>
            <a:off x="1899295" y="1206342"/>
            <a:ext cx="2372400" cy="2520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971600" y="1206342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096167" y="1615842"/>
            <a:ext cx="7589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600" dirty="0">
                <a:latin typeface="Times New Roman" panose="02020603050405020304" pitchFamily="18" charset="0"/>
                <a:ea typeface="宋体"/>
                <a:cs typeface="Times New Roman" panose="02020603050405020304" pitchFamily="18" charset="0"/>
              </a:rPr>
              <a:t>β</a:t>
            </a:r>
            <a:r>
              <a:rPr lang="en-US" altLang="zh-CN" sz="1600" dirty="0" smtClean="0">
                <a:latin typeface="Times New Roman" panose="02020603050405020304" pitchFamily="18" charset="0"/>
                <a:ea typeface="宋体"/>
                <a:cs typeface="Times New Roman" panose="02020603050405020304" pitchFamily="18" charset="0"/>
              </a:rPr>
              <a:t>-actin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140318" y="1163065"/>
            <a:ext cx="7589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p53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919040" y="578290"/>
            <a:ext cx="379697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T1720        -           +       -          +   </a:t>
            </a:r>
          </a:p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LPS        -            -       +          +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" name="图表 10"/>
          <p:cNvGraphicFramePr/>
          <p:nvPr>
            <p:extLst>
              <p:ext uri="{D42A27DB-BD31-4B8C-83A1-F6EECF244321}">
                <p14:modId xmlns:p14="http://schemas.microsoft.com/office/powerpoint/2010/main" val="3160496252"/>
              </p:ext>
            </p:extLst>
          </p:nvPr>
        </p:nvGraphicFramePr>
        <p:xfrm>
          <a:off x="5148064" y="126236"/>
          <a:ext cx="2879059" cy="21602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2" name="TextBox 11"/>
          <p:cNvSpPr txBox="1"/>
          <p:nvPr/>
        </p:nvSpPr>
        <p:spPr>
          <a:xfrm rot="16200000">
            <a:off x="4334765" y="986530"/>
            <a:ext cx="1781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p53 expressio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8905996">
            <a:off x="5567467" y="2193341"/>
            <a:ext cx="7560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    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8824702">
            <a:off x="5943907" y="2161878"/>
            <a:ext cx="10692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T1720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8934281">
            <a:off x="6701387" y="2198679"/>
            <a:ext cx="7756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LPS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8752603">
            <a:off x="6998545" y="2216042"/>
            <a:ext cx="12924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T1720+LPS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54527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</TotalTime>
  <Words>24</Words>
  <Application>Microsoft Office PowerPoint</Application>
  <PresentationFormat>自定义</PresentationFormat>
  <Paragraphs>9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lenovo</cp:lastModifiedBy>
  <cp:revision>6</cp:revision>
  <dcterms:created xsi:type="dcterms:W3CDTF">2017-08-10T11:46:41Z</dcterms:created>
  <dcterms:modified xsi:type="dcterms:W3CDTF">2017-10-06T14:28:18Z</dcterms:modified>
</cp:coreProperties>
</file>